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6336E-66BE-4B94-9ED5-57FA1EDDD7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A1748-730C-4F85-9D0D-A4DCE30C19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91009-73D8-4232-A91D-1D7905507E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3FA23-A353-4B83-981C-2DC3255C68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FD363-6F3A-446A-8FBC-AD6DE2BAE1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CF9FA-4F36-40E1-96FA-9EB3BD73F3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0882B-E1C3-4E00-B75C-AD5560E013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0EDC42-6D2F-49C4-B59A-276389EE22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DDEA08-6BC0-49E9-B71E-B20AF91E1D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6C7F8-79D8-4F93-A33F-AB81822634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741E94-F4EF-4716-AE44-47C731FE2E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4BDC11-4080-419B-B588-0E169004CC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8C0C07-0783-4D8A-8C6A-A666DAC272E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5848200" y="15228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Fig.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8"/>
          <p:cNvSpPr/>
          <p:nvPr/>
        </p:nvSpPr>
        <p:spPr>
          <a:xfrm>
            <a:off x="304920" y="7942320"/>
            <a:ext cx="594360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The UCSC Browser view of raw RNA-seq data shows the examples of split and un-split tags around the splicing junction of Smad7</a:t>
            </a:r>
            <a:r>
              <a:rPr b="0" lang="el-GR" sz="1100" spc="-1" strike="noStrike">
                <a:solidFill>
                  <a:srgbClr val="000000"/>
                </a:solidFill>
                <a:latin typeface="Calibri"/>
                <a:ea typeface="Arial"/>
              </a:rPr>
              <a:t>Δ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 in (A) Mouse embryonic fibroblasts and (B) Human Osteosarcoma cell line HOS.  Red arrows indicate the split tags. Since our RNA-seq sequencing depth is too large to be displayed completely, we have truncated the browser view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2" descr=""/>
          <p:cNvPicPr/>
          <p:nvPr/>
        </p:nvPicPr>
        <p:blipFill>
          <a:blip r:embed="rId1"/>
          <a:stretch/>
        </p:blipFill>
        <p:spPr>
          <a:xfrm>
            <a:off x="88920" y="549360"/>
            <a:ext cx="4559400" cy="3601800"/>
          </a:xfrm>
          <a:prstGeom prst="rect">
            <a:avLst/>
          </a:prstGeom>
          <a:ln w="0">
            <a:noFill/>
          </a:ln>
        </p:spPr>
      </p:pic>
      <p:sp>
        <p:nvSpPr>
          <p:cNvPr id="44" name="TextBox 21"/>
          <p:cNvSpPr/>
          <p:nvPr/>
        </p:nvSpPr>
        <p:spPr>
          <a:xfrm>
            <a:off x="39600" y="76320"/>
            <a:ext cx="409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5"/>
          <p:cNvSpPr/>
          <p:nvPr/>
        </p:nvSpPr>
        <p:spPr>
          <a:xfrm>
            <a:off x="5322960" y="5715000"/>
            <a:ext cx="145872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HOS cells (SMAD7∆ percentage is 1/82=1.2%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26"/>
          <p:cNvSpPr/>
          <p:nvPr/>
        </p:nvSpPr>
        <p:spPr>
          <a:xfrm>
            <a:off x="2577960" y="7219800"/>
            <a:ext cx="1702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Exon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28"/>
          <p:cNvSpPr/>
          <p:nvPr/>
        </p:nvSpPr>
        <p:spPr>
          <a:xfrm>
            <a:off x="5386320" y="7023240"/>
            <a:ext cx="170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Human SMAD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30"/>
          <p:cNvSpPr/>
          <p:nvPr/>
        </p:nvSpPr>
        <p:spPr>
          <a:xfrm>
            <a:off x="49320" y="4572000"/>
            <a:ext cx="411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2"/>
          <a:stretch/>
        </p:blipFill>
        <p:spPr>
          <a:xfrm>
            <a:off x="563400" y="4916520"/>
            <a:ext cx="4754880" cy="2279520"/>
          </a:xfrm>
          <a:prstGeom prst="rect">
            <a:avLst/>
          </a:prstGeom>
          <a:ln w="0">
            <a:noFill/>
          </a:ln>
        </p:spPr>
      </p:pic>
      <p:sp>
        <p:nvSpPr>
          <p:cNvPr id="50" name="TextBox 17"/>
          <p:cNvSpPr/>
          <p:nvPr/>
        </p:nvSpPr>
        <p:spPr>
          <a:xfrm>
            <a:off x="5397480" y="3962520"/>
            <a:ext cx="170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Mouse SMAD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8"/>
          <p:cNvSpPr/>
          <p:nvPr/>
        </p:nvSpPr>
        <p:spPr>
          <a:xfrm>
            <a:off x="5094360" y="1447920"/>
            <a:ext cx="145872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MEF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(SMAD7∆ percentage is 14/741=2%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15T20:25:31Z</dcterms:created>
  <dc:creator>Shukla, Anjali (NIH/NCI) [E]</dc:creator>
  <dc:description/>
  <dc:language>en-US</dc:language>
  <cp:lastModifiedBy>Shukla, Anjali (NIH/NCI) [E]</cp:lastModifiedBy>
  <dcterms:modified xsi:type="dcterms:W3CDTF">2016-08-09T18:34:55Z</dcterms:modified>
  <cp:revision>2</cp:revision>
  <dc:subject/>
  <dc:title>PowerPoint Presentation</dc:title>
</cp:coreProperties>
</file>